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84" r:id="rId2"/>
  </p:sldMasterIdLst>
  <p:notesMasterIdLst>
    <p:notesMasterId r:id="rId8"/>
  </p:notesMasterIdLst>
  <p:sldIdLst>
    <p:sldId id="281" r:id="rId3"/>
    <p:sldId id="283" r:id="rId4"/>
    <p:sldId id="259" r:id="rId5"/>
    <p:sldId id="293" r:id="rId6"/>
    <p:sldId id="292" r:id="rId7"/>
  </p:sldIdLst>
  <p:sldSz cx="6858000" cy="9906000" type="A4"/>
  <p:notesSz cx="6794500" cy="9931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44" autoAdjust="0"/>
    <p:restoredTop sz="96103" autoAdjust="0"/>
  </p:normalViewPr>
  <p:slideViewPr>
    <p:cSldViewPr>
      <p:cViewPr varScale="1">
        <p:scale>
          <a:sx n="72" d="100"/>
          <a:sy n="72" d="100"/>
        </p:scale>
        <p:origin x="1944" y="60"/>
      </p:cViewPr>
      <p:guideLst>
        <p:guide orient="horz" pos="3120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44E9FB-0CD5-46EC-92CA-2DDD62BE7F22}" type="datetimeFigureOut">
              <a:rPr lang="en-GB" smtClean="0"/>
              <a:t>04/09/2025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1775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9486"/>
            <a:ext cx="543560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22B89A-030B-4923-8701-B599C2C9F17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57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F9ADB4-546B-4899-8EB7-40336FA4FAA0}" type="slidenum">
              <a:rPr lang="pt-BR" smtClean="0"/>
              <a:t>3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23164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10E391C-99CD-4CD8-B8FC-2B7BDAC4D3B6}" type="slidenum">
              <a:rPr kumimoji="0" lang="pt-B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pt-B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205669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6C845CF-B45F-46F1-83A8-62111E9E0EBA}" type="slidenum">
              <a:rPr kumimoji="0" lang="pt-B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pt-B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033203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5310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2713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493439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153B0F9-6D26-44CB-8104-781C0E751F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F117DB8-7A74-4551-9FC6-FAAAC1CC21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70448FA-7A32-40AC-8989-9DB5602E5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A3A61A3-23F7-4000-B060-A722EF3B3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BAF3031-4E1D-4C97-9F21-705A1D176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350012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CE594E-4671-41F2-B44A-DBBC3D716E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DFCED71B-40F7-42FC-980D-D71F00143E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2468FB2-FE19-40D8-B23E-1C0A4324D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113F519-26B7-4DF8-87CB-52654CB7F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F7C4AF9-6F83-4F5C-8F6D-BED7DE594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942595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E5A7C87-1A58-4CEF-8027-A2B5DEF55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1100782-8300-40C1-8E7E-3C344A0C56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E8ECFA2-DC35-467C-BD8C-8D2432F3E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DE5FC6B-4EB5-494D-A331-F126B75A5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DA2D44A-A3E3-4F7B-AB1E-363D529F0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584332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224C34C-1BFF-428A-81BA-2BFE89FC69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18E4C41F-44D2-44B7-860F-D004EE3883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9E9C6D39-A44A-4790-B9AD-512B4EE107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92922D7C-93C7-4F46-8F41-8FDA97A82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1D6119C1-726D-41E9-81D0-654ECB815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CFB00A3-04E3-46F6-B268-EBC860D13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2200803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6953C0-D5A3-47A9-B57D-D8E0109264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4A9F66D-B404-460F-BF26-367F94B2C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199CC1C3-1B82-49D5-9173-B05ACE5565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A0E8DBEF-88C6-4CE7-8991-BB1DF5646B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B11B3FC4-5BE5-430B-B447-499931FBE3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854C04B4-6E4B-479D-9638-741630BCC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B797CAD1-DD12-4C52-B1D9-5F64EFFAE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F5EE85FB-76E9-4C7D-9223-ED4AD71C2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5648617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2F61458-1AD7-4AF9-B1DB-287A33E0E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31289FA1-FFC0-461A-8DDB-A9211867E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C744740E-DFB1-4633-83D9-E9FFEDC06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D1EDED5B-A887-416D-B79F-1CBEF2C68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641477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C43CF0E0-A275-45E6-B603-C230524EA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3354E78D-EE06-4DB6-9AD9-76B0CC8A8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49DEB0A-95AA-45D1-A751-03145FF0A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7874757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CDC5FD5-8C9F-49C5-9A73-F6DF49159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4FB46DF-F5BC-4066-8792-D86D184329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0EE9AA8D-9809-4DD0-A833-4284BA51B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38D044F-CAAC-4A42-B694-BC3BAA41B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1DF1515-64CE-4AFA-AF1B-10928FCB2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B3B75F4-1A52-4ADB-93C3-7750F4CF2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73240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215694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1DA29C-F2C9-42BF-87F2-36070B6B5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8F64D49B-C46C-422E-9FBE-AB4592003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015CDD3-BDD8-4B90-A15E-90DE660126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2FA0A6F-04AE-4973-9FD7-01761E9D3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8028510-2372-45A1-A59D-300CC21C4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FC59EA0C-886A-4233-B548-3E8396A27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260347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29602C-3C8A-4006-A065-B7C40D6B19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AFE2A63-DCB8-45DF-B29E-A8146E2292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5F57C0D-FE64-4D2A-9F09-8336FB223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28AE260-D682-4373-A2DC-D1817C118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540F5EF-17D3-4947-8BE7-57F0A4005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1881364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D06A8E2-CF63-4185-9A58-66280AFC57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C5D1C4C4-1333-4889-B90F-F93C4B2BD2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028D10A-1D99-4D98-97F4-9D1428F61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B93F33-4463-4893-B42B-CABB8DDC3C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B43C48-F563-4C36-9D05-DAD7B5931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24865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7861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4509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409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4538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6001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0673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5909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8C393-AB42-495A-94E9-5180AE60CC78}" type="datetimeFigureOut">
              <a:rPr lang="de-DE" smtClean="0"/>
              <a:t>04.09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D230B-DB36-4BE1-90DE-612947424C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1064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6450155D-C564-41CD-8AD9-64E96B1AC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ADA439DA-EDC7-48EA-8F3C-AC08A5D6A6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6AA4C28-6995-4768-BA25-196321344D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556A7-A1CA-44B9-92E7-A2834E15EAB4}" type="datetimeFigureOut">
              <a:rPr lang="pt-BR" smtClean="0"/>
              <a:t>04/09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08A1B55-AB04-4AAD-B5B9-832083850A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D38B1B9-11D1-4EAB-BECE-126846669F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B6FA5-4742-4E8E-BFF3-F91216047B17}" type="slidenum">
              <a:rPr lang="pt-BR" smtClean="0"/>
              <a:t>‹Nr.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275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5" Type="http://schemas.openxmlformats.org/officeDocument/2006/relationships/image" Target="../media/image5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3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png"/><Relationship Id="rId5" Type="http://schemas.openxmlformats.org/officeDocument/2006/relationships/image" Target="../media/image7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>
            <a:extLst>
              <a:ext uri="{FF2B5EF4-FFF2-40B4-BE49-F238E27FC236}">
                <a16:creationId xmlns:a16="http://schemas.microsoft.com/office/drawing/2014/main" id="{63FF7962-4247-4379-AE8F-A1542DA80D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88" y="570952"/>
            <a:ext cx="6767819" cy="3257048"/>
          </a:xfrm>
          <a:prstGeom prst="rect">
            <a:avLst/>
          </a:prstGeom>
        </p:spPr>
      </p:pic>
      <p:sp>
        <p:nvSpPr>
          <p:cNvPr id="2" name="Rechteck 1">
            <a:extLst>
              <a:ext uri="{FF2B5EF4-FFF2-40B4-BE49-F238E27FC236}">
                <a16:creationId xmlns:a16="http://schemas.microsoft.com/office/drawing/2014/main" id="{FCEA348F-2741-4D47-9C23-828A1E6AC660}"/>
              </a:ext>
            </a:extLst>
          </p:cNvPr>
          <p:cNvSpPr/>
          <p:nvPr/>
        </p:nvSpPr>
        <p:spPr>
          <a:xfrm>
            <a:off x="92888" y="4021281"/>
            <a:ext cx="6570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1: </a:t>
            </a:r>
            <a:r>
              <a:rPr lang="en-GB" sz="1200" b="1" i="1" dirty="0"/>
              <a:t>S. aureus</a:t>
            </a:r>
            <a:r>
              <a:rPr lang="en-GB" sz="1200" b="1" dirty="0"/>
              <a:t> does not disseminate systemically in mice with PGA. </a:t>
            </a:r>
            <a:r>
              <a:rPr lang="en-GB" sz="1200" i="1" dirty="0"/>
              <a:t>S. aureus </a:t>
            </a:r>
            <a:r>
              <a:rPr lang="en-GB" sz="1200" dirty="0"/>
              <a:t>CFUs were quantified in the lungs, liver, kidneys, heart, spleen, and urine using </a:t>
            </a:r>
            <a:r>
              <a:rPr lang="en-GB" sz="1200" dirty="0" err="1"/>
              <a:t>CHROMagar</a:t>
            </a:r>
            <a:r>
              <a:rPr lang="en-GB" sz="1200" dirty="0"/>
              <a:t> selective plates. Groups include: naïve (</a:t>
            </a:r>
            <a:r>
              <a:rPr lang="en-GB" sz="1200" i="1" dirty="0"/>
              <a:t>S. aureus</a:t>
            </a:r>
            <a:r>
              <a:rPr lang="en-GB" sz="1200" dirty="0"/>
              <a:t>-free mice), No PGA (</a:t>
            </a:r>
            <a:r>
              <a:rPr lang="en-GB" sz="1200" i="1" dirty="0"/>
              <a:t>S. aureus</a:t>
            </a:r>
            <a:r>
              <a:rPr lang="en-GB" sz="1200" dirty="0"/>
              <a:t> JSNZ-colonized without preputial gland infection), and PGA (</a:t>
            </a:r>
            <a:r>
              <a:rPr lang="en-GB" sz="1200" i="1" dirty="0"/>
              <a:t>S. aureus </a:t>
            </a:r>
            <a:r>
              <a:rPr lang="en-GB" sz="1200" dirty="0"/>
              <a:t>JSNZ-colonized with preputial gland infection). Each data point represents one animal (CFU value is the median of three technical replicates). Data are presented as median with interquartile range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5218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>
            <a:extLst>
              <a:ext uri="{FF2B5EF4-FFF2-40B4-BE49-F238E27FC236}">
                <a16:creationId xmlns:a16="http://schemas.microsoft.com/office/drawing/2014/main" id="{DC2F7481-9B5C-4A8A-A6DE-0AD411BA9C4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69" r="88"/>
          <a:stretch/>
        </p:blipFill>
        <p:spPr>
          <a:xfrm>
            <a:off x="6060" y="903000"/>
            <a:ext cx="6851940" cy="4759200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906A0030-BF6A-487B-8AE3-2F62FA13C17D}"/>
              </a:ext>
            </a:extLst>
          </p:cNvPr>
          <p:cNvSpPr txBox="1"/>
          <p:nvPr/>
        </p:nvSpPr>
        <p:spPr>
          <a:xfrm>
            <a:off x="189000" y="5707200"/>
            <a:ext cx="6119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: </a:t>
            </a:r>
            <a:r>
              <a:rPr lang="en-GB" sz="1200" b="1" dirty="0"/>
              <a:t>Serum cytokines are not affected by PGA. </a:t>
            </a:r>
            <a:r>
              <a:rPr lang="en-GB" sz="1200" dirty="0"/>
              <a:t>Heat map illustrating cytokine and chemokine concentrations in serum samples from </a:t>
            </a:r>
            <a:r>
              <a:rPr lang="en-GB" sz="1200" i="1" dirty="0"/>
              <a:t>S. aureus</a:t>
            </a:r>
            <a:r>
              <a:rPr lang="en-GB" sz="1200" dirty="0"/>
              <a:t>-free naïve male mice (Naïve, n = 11), male mice colonized with </a:t>
            </a:r>
            <a:r>
              <a:rPr lang="en-GB" sz="1200" i="1" dirty="0"/>
              <a:t>S. aureus </a:t>
            </a:r>
            <a:r>
              <a:rPr lang="en-GB" sz="1200" dirty="0"/>
              <a:t>JSNZ without PGA (No PGA, n = 6), and male mice colonized with JSNZ with PGA (PGA, n = 19). Cytokine and chemokine concentrations were log₁₀-transformed and hierarchically clustered. For IL-2 and IL-17F all samples were below the detection limit and set at LOD/2.</a:t>
            </a:r>
            <a:endParaRPr lang="de-DE" sz="1200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64B11320-50DA-4281-9360-D17C95EE12C5}"/>
              </a:ext>
            </a:extLst>
          </p:cNvPr>
          <p:cNvSpPr txBox="1"/>
          <p:nvPr/>
        </p:nvSpPr>
        <p:spPr>
          <a:xfrm>
            <a:off x="5724000" y="2568000"/>
            <a:ext cx="1080000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bIns="0" rtlCol="0">
            <a:spAutoFit/>
          </a:bodyPr>
          <a:lstStyle/>
          <a:p>
            <a:r>
              <a:rPr lang="en-US" sz="900" b="1" dirty="0"/>
              <a:t>log</a:t>
            </a:r>
            <a:r>
              <a:rPr lang="en-US" sz="900" b="1" baseline="-25000" dirty="0"/>
              <a:t>10</a:t>
            </a:r>
            <a:r>
              <a:rPr lang="en-US" sz="900" b="1" dirty="0"/>
              <a:t> concentration      </a:t>
            </a:r>
          </a:p>
          <a:p>
            <a:r>
              <a:rPr lang="en-US" sz="900" b="1" dirty="0"/>
              <a:t>(</a:t>
            </a:r>
            <a:r>
              <a:rPr lang="en-US" sz="900" b="1" dirty="0" err="1"/>
              <a:t>pg</a:t>
            </a:r>
            <a:r>
              <a:rPr lang="en-US" sz="900" b="1" dirty="0"/>
              <a:t>/mL)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A8EEA446-166B-4957-9F3D-DACEB4870F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99" t="53381" r="30587" b="26416"/>
          <a:stretch/>
        </p:blipFill>
        <p:spPr>
          <a:xfrm>
            <a:off x="1377608" y="593668"/>
            <a:ext cx="392143" cy="277101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985F89B-276F-4BBC-A119-FFD364161B2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99" t="53381" r="30587" b="26416"/>
          <a:stretch/>
        </p:blipFill>
        <p:spPr>
          <a:xfrm>
            <a:off x="2548024" y="593668"/>
            <a:ext cx="392143" cy="277101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3061ADBD-CFC8-4D9A-9BBB-78962ABF889C}"/>
              </a:ext>
            </a:extLst>
          </p:cNvPr>
          <p:cNvSpPr txBox="1"/>
          <p:nvPr/>
        </p:nvSpPr>
        <p:spPr>
          <a:xfrm>
            <a:off x="1314000" y="318000"/>
            <a:ext cx="5196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Naive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FE054E4-CFEB-49F9-8A45-25D355F402FB}"/>
              </a:ext>
            </a:extLst>
          </p:cNvPr>
          <p:cNvSpPr txBox="1"/>
          <p:nvPr/>
        </p:nvSpPr>
        <p:spPr>
          <a:xfrm>
            <a:off x="2433890" y="318000"/>
            <a:ext cx="6351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/>
              <a:t>No</a:t>
            </a:r>
            <a:r>
              <a:rPr lang="de-DE" sz="1100" b="1" dirty="0"/>
              <a:t> PGA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A64EE43-7421-4935-A2E0-8A88F41535B7}"/>
              </a:ext>
            </a:extLst>
          </p:cNvPr>
          <p:cNvSpPr txBox="1"/>
          <p:nvPr/>
        </p:nvSpPr>
        <p:spPr>
          <a:xfrm>
            <a:off x="4119266" y="318000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PGA</a:t>
            </a: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69C71C73-100D-48C2-8135-D4D30710156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14" t="70806" r="1545" b="8756"/>
          <a:stretch/>
        </p:blipFill>
        <p:spPr>
          <a:xfrm>
            <a:off x="3889136" y="581178"/>
            <a:ext cx="429506" cy="302081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9E3F3EA3-F408-4C14-9124-23276E9CD58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4" t="7249" r="3412" b="71990"/>
          <a:stretch/>
        </p:blipFill>
        <p:spPr>
          <a:xfrm>
            <a:off x="4429741" y="581178"/>
            <a:ext cx="450111" cy="302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72775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F6032EE8-7203-449C-BD56-120FC3C5C9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7339942"/>
              </p:ext>
            </p:extLst>
          </p:nvPr>
        </p:nvGraphicFramePr>
        <p:xfrm>
          <a:off x="698931" y="198481"/>
          <a:ext cx="6094644" cy="47545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42" name="Prism 8" r:id="rId4" imgW="9193184" imgH="7172859" progId="Prism8.Document">
                  <p:embed/>
                </p:oleObj>
              </mc:Choice>
              <mc:Fallback>
                <p:oleObj name="Prism 8" r:id="rId4" imgW="9193184" imgH="7172859" progId="Prism8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F6032EE8-7203-449C-BD56-120FC3C5C9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98931" y="198481"/>
                        <a:ext cx="6094644" cy="47545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CaixaDeTexto 13">
            <a:extLst>
              <a:ext uri="{FF2B5EF4-FFF2-40B4-BE49-F238E27FC236}">
                <a16:creationId xmlns:a16="http://schemas.microsoft.com/office/drawing/2014/main" id="{0A39EB58-A5F2-4DD1-8BFB-765B0DF28257}"/>
              </a:ext>
            </a:extLst>
          </p:cNvPr>
          <p:cNvSpPr txBox="1"/>
          <p:nvPr/>
        </p:nvSpPr>
        <p:spPr>
          <a:xfrm>
            <a:off x="27465" y="1880842"/>
            <a:ext cx="7293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0CDCFB5F-582C-4B46-B228-B243A3C06622}"/>
              </a:ext>
            </a:extLst>
          </p:cNvPr>
          <p:cNvSpPr txBox="1"/>
          <p:nvPr/>
        </p:nvSpPr>
        <p:spPr>
          <a:xfrm>
            <a:off x="27465" y="2947290"/>
            <a:ext cx="729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roliferated CD4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5E35BF14-E39E-4631-9945-1083AFB2E384}"/>
              </a:ext>
            </a:extLst>
          </p:cNvPr>
          <p:cNvSpPr txBox="1"/>
          <p:nvPr/>
        </p:nvSpPr>
        <p:spPr>
          <a:xfrm>
            <a:off x="-8674" y="3981820"/>
            <a:ext cx="80163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roliferated CD4</a:t>
            </a:r>
            <a:r>
              <a:rPr lang="en-US" sz="7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eff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em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Tcm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pt-B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Imagem 16">
            <a:extLst>
              <a:ext uri="{FF2B5EF4-FFF2-40B4-BE49-F238E27FC236}">
                <a16:creationId xmlns:a16="http://schemas.microsoft.com/office/drawing/2014/main" id="{183C3592-AFAB-4C98-BBFD-C8AD15C7273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77743"/>
          <a:stretch/>
        </p:blipFill>
        <p:spPr>
          <a:xfrm>
            <a:off x="4379594" y="666055"/>
            <a:ext cx="326236" cy="516120"/>
          </a:xfrm>
          <a:prstGeom prst="rect">
            <a:avLst/>
          </a:prstGeom>
        </p:spPr>
      </p:pic>
      <p:sp>
        <p:nvSpPr>
          <p:cNvPr id="18" name="CaixaDeTexto 17">
            <a:extLst>
              <a:ext uri="{FF2B5EF4-FFF2-40B4-BE49-F238E27FC236}">
                <a16:creationId xmlns:a16="http://schemas.microsoft.com/office/drawing/2014/main" id="{F0E5DB24-6C50-4874-8EF4-8DDB53000526}"/>
              </a:ext>
            </a:extLst>
          </p:cNvPr>
          <p:cNvSpPr txBox="1"/>
          <p:nvPr/>
        </p:nvSpPr>
        <p:spPr>
          <a:xfrm>
            <a:off x="4661048" y="713712"/>
            <a:ext cx="1227646" cy="4246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1350"/>
              </a:spcBef>
              <a:spcAft>
                <a:spcPts val="675"/>
              </a:spcAft>
            </a:pPr>
            <a:r>
              <a:rPr lang="en-US" sz="788" b="1" dirty="0">
                <a:latin typeface="Arial" panose="020B0604020202020204" pitchFamily="34" charset="0"/>
                <a:cs typeface="Arial" panose="020B0604020202020204" pitchFamily="34" charset="0"/>
              </a:rPr>
              <a:t>No stimulation</a:t>
            </a:r>
          </a:p>
          <a:p>
            <a:r>
              <a:rPr lang="en-US" sz="788" b="1" dirty="0">
                <a:latin typeface="Arial" panose="020B0604020202020204" pitchFamily="34" charset="0"/>
                <a:cs typeface="Arial" panose="020B0604020202020204" pitchFamily="34" charset="0"/>
              </a:rPr>
              <a:t>With stimulation</a:t>
            </a:r>
            <a:endParaRPr lang="pt-BR" sz="78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F5D4A7D-4BE8-47E8-8174-8BF5C5524D32}"/>
              </a:ext>
            </a:extLst>
          </p:cNvPr>
          <p:cNvSpPr/>
          <p:nvPr/>
        </p:nvSpPr>
        <p:spPr>
          <a:xfrm>
            <a:off x="130740" y="5313000"/>
            <a:ext cx="6583260" cy="24550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: Absolute cell counts for re-stimulated splenocytes from </a:t>
            </a:r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colonized PGA-free and JSNZ-colonized PGA-positive mice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lenocytes from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JSNZ-colonized C57BL/6NRj mice with PGA were labelled with CFSE and cultured in the presence or absence of an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tigen cocktail for 4 days. Animals that were naïve to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JSNZ but were later found to be colonized with an 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aureu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C15 isolate were used as colonized, but PGA-negative control group (no PGA). Proliferation of CD4</a:t>
            </a:r>
            <a:r>
              <a:rPr lang="en-US" sz="12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8</a:t>
            </a:r>
            <a:r>
              <a:rPr lang="en-US" sz="12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 was analyzed by flow cytometry along with the lineage-specific transcription factor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Rγt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T-bet, GATA3 and FOXP3 within Th cell populations. Within CD4 T cell population, effector/effector memory T cells (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m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central memory T cells (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cm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ere identified as CD44</a:t>
            </a:r>
            <a:r>
              <a:rPr lang="en-US" sz="12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62L</a:t>
            </a:r>
            <a:r>
              <a:rPr lang="en-US" sz="12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44</a:t>
            </a:r>
            <a:r>
              <a:rPr lang="en-US" sz="12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62L</a:t>
            </a:r>
            <a:r>
              <a:rPr lang="en-US" sz="1200" baseline="30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spectively. Data are displayed as absolute cell numbers. Each data point represents one mouse (4-5 mice/group). Data are presented as mean with SEM. Statistics: Ordinary one-way ANOVA/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dak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est with multiple comparisons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p ≤ 0.05 (*), p ≤ 0.01 (**), p ≤ 0.001 (***), p ≤ 0.0001 (****)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1301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6A312B62-5B2E-4DA4-93EB-5DA2C23FCF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1388000"/>
              </p:ext>
            </p:extLst>
          </p:nvPr>
        </p:nvGraphicFramePr>
        <p:xfrm>
          <a:off x="261400" y="267058"/>
          <a:ext cx="6387266" cy="64409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18" name="Prism 8" r:id="rId4" imgW="7058660" imgH="7118445" progId="Prism8.Document">
                  <p:embed/>
                </p:oleObj>
              </mc:Choice>
              <mc:Fallback>
                <p:oleObj name="Prism 8" r:id="rId4" imgW="7058660" imgH="711844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1400" y="267058"/>
                        <a:ext cx="6387266" cy="64409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Imagem 5">
            <a:extLst>
              <a:ext uri="{FF2B5EF4-FFF2-40B4-BE49-F238E27FC236}">
                <a16:creationId xmlns:a16="http://schemas.microsoft.com/office/drawing/2014/main" id="{E10A0214-4BA0-43A7-82A4-1BD8DB1C8C3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77743"/>
          <a:stretch/>
        </p:blipFill>
        <p:spPr>
          <a:xfrm>
            <a:off x="5051446" y="711685"/>
            <a:ext cx="326236" cy="516120"/>
          </a:xfrm>
          <a:prstGeom prst="rect">
            <a:avLst/>
          </a:prstGeom>
        </p:spPr>
      </p:pic>
      <p:sp>
        <p:nvSpPr>
          <p:cNvPr id="7" name="CaixaDeTexto 6">
            <a:extLst>
              <a:ext uri="{FF2B5EF4-FFF2-40B4-BE49-F238E27FC236}">
                <a16:creationId xmlns:a16="http://schemas.microsoft.com/office/drawing/2014/main" id="{E3313526-50DB-42C1-AC64-C7CDD84B6C80}"/>
              </a:ext>
            </a:extLst>
          </p:cNvPr>
          <p:cNvSpPr txBox="1"/>
          <p:nvPr/>
        </p:nvSpPr>
        <p:spPr>
          <a:xfrm>
            <a:off x="5332900" y="759342"/>
            <a:ext cx="1227646" cy="4246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50">
              <a:spcBef>
                <a:spcPts val="1350"/>
              </a:spcBef>
              <a:spcAft>
                <a:spcPts val="675"/>
              </a:spcAft>
            </a:pPr>
            <a:r>
              <a:rPr lang="en-US" sz="788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stimulation</a:t>
            </a:r>
          </a:p>
          <a:p>
            <a:pPr defTabSz="514350"/>
            <a:r>
              <a:rPr lang="en-US" sz="788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stimulation</a:t>
            </a:r>
            <a:endParaRPr lang="pt-BR" sz="788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B37CC119-48A4-4380-BB91-F30D95FBC4DE}"/>
              </a:ext>
            </a:extLst>
          </p:cNvPr>
          <p:cNvSpPr/>
          <p:nvPr/>
        </p:nvSpPr>
        <p:spPr>
          <a:xfrm>
            <a:off x="45000" y="7023000"/>
            <a:ext cx="6579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4: </a:t>
            </a:r>
            <a:r>
              <a:rPr lang="en-US" sz="1200" b="1" i="1" dirty="0"/>
              <a:t>S. aureus</a:t>
            </a:r>
            <a:r>
              <a:rPr lang="en-US" sz="1200" b="1" dirty="0"/>
              <a:t>-specific T cells release Th1, Th2, Th9, Th17 and </a:t>
            </a:r>
            <a:r>
              <a:rPr lang="en-US" sz="1200" b="1" dirty="0" err="1"/>
              <a:t>Treg</a:t>
            </a:r>
            <a:r>
              <a:rPr lang="en-US" sz="1200" b="1" dirty="0"/>
              <a:t>-related cytokines. </a:t>
            </a:r>
            <a:r>
              <a:rPr lang="en-US" sz="1200" dirty="0"/>
              <a:t>Cells from iliac lymph nodes (ILN) or splenocytes from </a:t>
            </a:r>
            <a:r>
              <a:rPr lang="en-US" sz="1200" i="1" dirty="0"/>
              <a:t>S. aureus</a:t>
            </a:r>
            <a:r>
              <a:rPr lang="en-US" sz="1200" dirty="0"/>
              <a:t> colonized C57BL/6NRj mice without PGA (no PGA) or with PGA (PGA) were labelled with CFSE and cultured in the presence or absence of an </a:t>
            </a:r>
            <a:r>
              <a:rPr lang="en-US" sz="1200" i="1" dirty="0"/>
              <a:t>S. aureus </a:t>
            </a:r>
            <a:r>
              <a:rPr lang="en-US" sz="1200" dirty="0"/>
              <a:t>antigen cocktail for 4 days. Cell-free supernatants were analyzed for cytokine release by a bead-based multiplex assay (</a:t>
            </a:r>
            <a:r>
              <a:rPr lang="en-US" sz="1200" dirty="0" err="1"/>
              <a:t>LEGENDplex</a:t>
            </a:r>
            <a:r>
              <a:rPr lang="en-US" sz="1200" dirty="0"/>
              <a:t>™ MU Th Cytokine Panel). Each data point represents one mouse (4 – 5 mice/group), except for ILN data (no PGA group) where one of the two data points presents pooled cells from three mice. Data are presented as mean with SEM. Statistics: Ordinary one-way ANOVA/</a:t>
            </a:r>
            <a:r>
              <a:rPr lang="en-US" sz="1200" dirty="0" err="1"/>
              <a:t>Sidak</a:t>
            </a:r>
            <a:r>
              <a:rPr lang="en-US" sz="1200" dirty="0"/>
              <a:t> test with multiple comparisons. *P≤0.05, **P≤0.005, ***P≤0.0005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574788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1FE46F45-20E9-4D69-B3A1-98EC16142842}"/>
              </a:ext>
            </a:extLst>
          </p:cNvPr>
          <p:cNvSpPr/>
          <p:nvPr/>
        </p:nvSpPr>
        <p:spPr>
          <a:xfrm>
            <a:off x="315553" y="5256600"/>
            <a:ext cx="627193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5: </a:t>
            </a:r>
            <a:r>
              <a:rPr lang="en-GB" sz="1200" b="1" dirty="0"/>
              <a:t>Flow cytometry gating strategy for identifying murine CD4</a:t>
            </a:r>
            <a:r>
              <a:rPr lang="en-GB" sz="1200" b="1" baseline="30000" dirty="0"/>
              <a:t>+</a:t>
            </a:r>
            <a:r>
              <a:rPr lang="en-GB" sz="1200" b="1" dirty="0"/>
              <a:t> and CD8</a:t>
            </a:r>
            <a:r>
              <a:rPr lang="en-GB" sz="1200" b="1" baseline="30000" dirty="0"/>
              <a:t>+</a:t>
            </a:r>
            <a:r>
              <a:rPr lang="en-GB" sz="1200" b="1" dirty="0"/>
              <a:t> T cell subsets in the spleen. </a:t>
            </a:r>
            <a:r>
              <a:rPr lang="en-US" sz="1200" dirty="0"/>
              <a:t>Single-cell suspensions of mouse splenocytes were CFSE-labelled and cultured in the presence or absence of an </a:t>
            </a:r>
            <a:r>
              <a:rPr lang="en-US" sz="1200" i="1" dirty="0"/>
              <a:t>S. aureus</a:t>
            </a:r>
            <a:r>
              <a:rPr lang="en-US" sz="1200" dirty="0"/>
              <a:t> antigen cocktail for 4 days. Cells were stained for surface and intracellular markers and analyzed by flow cytometry. Following isolation of singlets using FSC/SSC, live cells were identified by excluding Zombie NIR™ positive cells. Next, live single cells were gated for Leukocytes (SSC-A/FSC-A) followed by the selection of the T cell population (CD3</a:t>
            </a:r>
            <a:r>
              <a:rPr lang="en-US" sz="1200" baseline="30000" dirty="0"/>
              <a:t>+</a:t>
            </a:r>
            <a:r>
              <a:rPr lang="en-US" sz="1200" dirty="0"/>
              <a:t>). CD4</a:t>
            </a:r>
            <a:r>
              <a:rPr lang="en-US" sz="1200" baseline="30000" dirty="0"/>
              <a:t>+</a:t>
            </a:r>
            <a:r>
              <a:rPr lang="en-US" sz="1200" dirty="0"/>
              <a:t> and CD8</a:t>
            </a:r>
            <a:r>
              <a:rPr lang="en-US" sz="1200" baseline="30000" dirty="0"/>
              <a:t>+</a:t>
            </a:r>
            <a:r>
              <a:rPr lang="en-US" sz="1200" dirty="0"/>
              <a:t> cells were gated within the CD3</a:t>
            </a:r>
            <a:r>
              <a:rPr lang="en-US" sz="1200" baseline="30000" dirty="0"/>
              <a:t>+</a:t>
            </a:r>
            <a:r>
              <a:rPr lang="en-US" sz="1200" dirty="0"/>
              <a:t> population. Each T cell type (CD4</a:t>
            </a:r>
            <a:r>
              <a:rPr lang="en-US" sz="1200" baseline="30000" dirty="0"/>
              <a:t>+</a:t>
            </a:r>
            <a:r>
              <a:rPr lang="en-US" sz="1200" dirty="0"/>
              <a:t> and CD8</a:t>
            </a:r>
            <a:r>
              <a:rPr lang="en-US" sz="1200" baseline="30000" dirty="0"/>
              <a:t>+</a:t>
            </a:r>
            <a:r>
              <a:rPr lang="en-US" sz="1200" dirty="0"/>
              <a:t>) was gated on CFSE</a:t>
            </a:r>
            <a:r>
              <a:rPr lang="en-US" sz="1200" baseline="30000" dirty="0"/>
              <a:t>-</a:t>
            </a:r>
            <a:r>
              <a:rPr lang="en-US" sz="1200" dirty="0"/>
              <a:t> to select proliferated cells. Effector and memory cells were identified within the proliferated CD4</a:t>
            </a:r>
            <a:r>
              <a:rPr lang="en-US" sz="1200" baseline="30000" dirty="0"/>
              <a:t>+</a:t>
            </a:r>
            <a:r>
              <a:rPr lang="en-US" sz="1200" dirty="0"/>
              <a:t> T cell population by using CD44 and CD62L markers. Effector (</a:t>
            </a:r>
            <a:r>
              <a:rPr lang="en-US" sz="1200" dirty="0" err="1"/>
              <a:t>Teff</a:t>
            </a:r>
            <a:r>
              <a:rPr lang="en-US" sz="1200" dirty="0"/>
              <a:t>) or effector memory T cells (</a:t>
            </a:r>
            <a:r>
              <a:rPr lang="en-US" sz="1200" dirty="0" err="1"/>
              <a:t>Tem</a:t>
            </a:r>
            <a:r>
              <a:rPr lang="en-US" sz="1200" dirty="0"/>
              <a:t>) were classified as CD44</a:t>
            </a:r>
            <a:r>
              <a:rPr lang="en-US" sz="1200" baseline="30000" dirty="0"/>
              <a:t>+</a:t>
            </a:r>
            <a:r>
              <a:rPr lang="en-US" sz="1200" dirty="0"/>
              <a:t>CD62L</a:t>
            </a:r>
            <a:r>
              <a:rPr lang="en-US" sz="1200" baseline="30000" dirty="0"/>
              <a:t>-</a:t>
            </a:r>
            <a:r>
              <a:rPr lang="en-US" sz="1200" dirty="0"/>
              <a:t> while central memory T cells (</a:t>
            </a:r>
            <a:r>
              <a:rPr lang="en-US" sz="1200" dirty="0" err="1"/>
              <a:t>Tcm</a:t>
            </a:r>
            <a:r>
              <a:rPr lang="en-US" sz="1200" dirty="0"/>
              <a:t>) were classified as CD44</a:t>
            </a:r>
            <a:r>
              <a:rPr lang="en-US" sz="1200" baseline="30000" dirty="0"/>
              <a:t>+</a:t>
            </a:r>
            <a:r>
              <a:rPr lang="en-US" sz="1200" dirty="0"/>
              <a:t>CD62L</a:t>
            </a:r>
            <a:r>
              <a:rPr lang="en-US" sz="1200" baseline="30000" dirty="0"/>
              <a:t>+</a:t>
            </a:r>
            <a:r>
              <a:rPr lang="en-US" sz="1200" dirty="0"/>
              <a:t>. Cells positive for T-bet, </a:t>
            </a:r>
            <a:r>
              <a:rPr lang="en-US" sz="1200" dirty="0" err="1"/>
              <a:t>RORγt</a:t>
            </a:r>
            <a:r>
              <a:rPr lang="en-US" sz="1200" dirty="0"/>
              <a:t>, GATA3 or FOXP3 were gated within CD4</a:t>
            </a:r>
            <a:r>
              <a:rPr lang="en-US" sz="1200" baseline="30000" dirty="0"/>
              <a:t>+</a:t>
            </a:r>
            <a:r>
              <a:rPr lang="en-US" sz="1200" dirty="0"/>
              <a:t> T cells, proliferated CD4</a:t>
            </a:r>
            <a:r>
              <a:rPr lang="en-US" sz="1200" baseline="30000" dirty="0"/>
              <a:t>+</a:t>
            </a:r>
            <a:r>
              <a:rPr lang="en-US" sz="1200" dirty="0"/>
              <a:t> T cells and within proliferated CD4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err="1"/>
              <a:t>Teff</a:t>
            </a:r>
            <a:r>
              <a:rPr lang="en-US" sz="1200" dirty="0"/>
              <a:t>/</a:t>
            </a:r>
            <a:r>
              <a:rPr lang="en-US" sz="1200" dirty="0" err="1"/>
              <a:t>Tem</a:t>
            </a:r>
            <a:r>
              <a:rPr lang="en-US" sz="1200" dirty="0"/>
              <a:t> and </a:t>
            </a:r>
            <a:r>
              <a:rPr lang="en-US" sz="1200" dirty="0" err="1"/>
              <a:t>Tcm</a:t>
            </a:r>
            <a:r>
              <a:rPr lang="en-US" sz="1200" dirty="0"/>
              <a:t> populations. The data presented are from in vitro-stimulated splenocytes from a mouse with PGA.</a:t>
            </a:r>
            <a:endParaRPr lang="de-DE" sz="12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4F50BBF7-1A40-4759-95A4-BEC5D1A385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18" y="453000"/>
            <a:ext cx="6858000" cy="46120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2276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64</Words>
  <Application>Microsoft Office PowerPoint</Application>
  <PresentationFormat>A4-Papier (210 x 297 mm)</PresentationFormat>
  <Paragraphs>20</Paragraphs>
  <Slides>5</Slides>
  <Notes>3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2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Tema do Office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a Holtfreter</dc:creator>
  <cp:lastModifiedBy>Silva Holtfreter</cp:lastModifiedBy>
  <cp:revision>280</cp:revision>
  <dcterms:created xsi:type="dcterms:W3CDTF">2022-06-20T08:02:35Z</dcterms:created>
  <dcterms:modified xsi:type="dcterms:W3CDTF">2025-09-04T13:50:29Z</dcterms:modified>
</cp:coreProperties>
</file>